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62DF83-F569-481C-B160-79BB82F17B7F}" v="10" dt="2024-09-26T08:54:13.72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9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7EBD81-DDCF-4394-9D53-15499AAC64DC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EFCC3-C08D-42E9-AE17-D801792739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6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5166-24B3-4E19-B995-E052CAF2FD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A9420C-74C9-49BB-AD41-28EE86C58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C8B18-351C-48E0-9472-A63092294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053A5-2EE6-4B5B-8C68-7AEFBAB58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936FA-2ECA-4E12-972C-072926AAC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8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DB603-F780-4278-B99F-10B213E58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24337-225E-4619-AD80-82B24D980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BD175-7A87-4606-B941-02F2CC391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3B324-66A8-4E27-AB83-83D80A714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7DD6-8B32-49D5-8C6C-67425064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3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58E29-E635-4399-9CD9-46327BC7CB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CAEA6-0304-4E7E-8DD9-4E7B3FDE7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22AF5-7E5B-41E4-BB84-26BB63BB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E407D-22C3-4181-9B8D-6F578826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47847-837C-4827-8211-DE386ABD2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94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984A5-DD37-4F65-A5C6-00D49147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3F39-45A7-4064-9419-38FA43480A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CFF4C-3DBE-4D7D-9D82-2B7311D9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96C82-54D2-4335-B75E-98F7FD02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9AE4-4915-4B70-ADF9-8803E011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4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FF222-E43C-497F-A8A0-86E98E72D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78A5E-6C7F-4F2A-BC05-AF16FFE72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85B8-86A9-4E5F-BBFC-BBD99D9D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3B987-0B15-4835-9466-D378DC5D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C07BE3-A330-4B3F-B8C8-221544BB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68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C8D33-B9CE-4060-86FF-D1E63DF07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DDC4-9E2C-470E-8614-FEF2C0C06F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CA981-C392-4CD8-874B-E445CA86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B2A15-259B-4351-97D8-AED26DA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A461E-7716-4F2C-A590-7E9C5F5BC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FD94-D0BF-4462-839C-302621E15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00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4A57A-19A1-4077-8939-730B5FFA5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2A289-EDA8-44A2-BDF5-D7CF7A688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2B2CC-1EE1-4F01-B2D8-3F5907591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5D7109-7E5E-4123-A877-9B5072C05A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9AE05-E585-4FEB-9FE4-5780487C8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F49309-17B0-433A-86BE-A146548F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D9909-C228-4A80-8EE4-422032604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7FB830-4967-4887-832C-6DE14DA72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56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8A0D-C8D7-41CD-9131-0FBA2A42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A9B54-893B-4E50-94CD-8053CD06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BE61D-B329-4B2D-8E6C-4CBF322A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A6BEC3-86B4-447C-A9EA-F11ADA3D8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588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14AE8A-D537-443B-97FE-D0A73B4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0BA55-1FEE-4324-9EA5-0596C0B5D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6D1075-0534-4C35-AA88-2767F4536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64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8152F-F243-4D26-9E4A-DA17E8B26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3255A-4C51-4196-A55C-F8E6119A9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06397-CE0B-4D42-9B8A-296B2A0E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6B42B-99D5-45EE-8825-3C877B033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BCDF0-27C7-4BEF-BF33-BBB1F02D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76C0-854F-47BF-8811-28B3A667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12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E49C9-BFAD-446C-809A-6BA92E42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36115C-F9B9-4CF2-BD07-B2ED49320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80B9A-0C94-4FDB-BD83-29C4D85B2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287A7-4E67-4825-8549-2CE233B7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D5B43-1D10-44D7-9329-2D734A5E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DBA00B-0818-4388-9EC9-000329D2F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05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CD8008-BD23-4FF3-B2C8-AEB1BFA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C2C572-2629-4EB6-8B9C-6F580C9A4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29891-84FF-4E29-8D3C-97CDFD2F13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97E2-6761-46FF-B48E-E80B97A8F655}" type="datetimeFigureOut">
              <a:rPr lang="en-GB" smtClean="0"/>
              <a:t>21/05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1E135-001E-4D84-A68E-E24216B85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5D331-C372-4209-83CA-16098BF2E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4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047B4D3-218F-8FA1-F7BA-579D31FAE623}"/>
              </a:ext>
            </a:extLst>
          </p:cNvPr>
          <p:cNvSpPr txBox="1"/>
          <p:nvPr/>
        </p:nvSpPr>
        <p:spPr>
          <a:xfrm>
            <a:off x="143620" y="5467755"/>
            <a:ext cx="11514980" cy="13494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5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Pathway analysis showing enriched GO terms or KEGG across different samples.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115000"/>
              </a:lnSpc>
            </a:pP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thways analysis using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, C, E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O term or (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, D, F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KEGG pathway enrichment analysis of tumour suppressor genes identified as IS and found to be upregulated (denoted by upwards, black arrow) or downregulated (denoted by downwards, grey arrow) in RNA-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q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ata across iPSC or HLC samples treated with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R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V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V. Various panels include comparisons between two data sets or 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single data set (shown up- or down- regulated in comparison to </a:t>
            </a:r>
            <a:r>
              <a:rPr lang="en-GB" sz="1200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ntransduced</a:t>
            </a: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), as shown by samples lines underneath panels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This identifies common pathways across various LV infected samples relevant for genotoxicity. Expression percentages of gene sets are indicated by dot sizes.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enjamini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Hochberg adjusted p values are indicated by colour gradients (P&lt;0.05)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888B714-CE7F-6CCB-76C4-46829D7CCE8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345"/>
          <a:stretch/>
        </p:blipFill>
        <p:spPr>
          <a:xfrm>
            <a:off x="143622" y="40773"/>
            <a:ext cx="7735600" cy="54269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7152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79</TotalTime>
  <Words>15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qlain Suleman (Staff)</dc:creator>
  <cp:lastModifiedBy>Suleman, Saqlain</cp:lastModifiedBy>
  <cp:revision>33</cp:revision>
  <dcterms:created xsi:type="dcterms:W3CDTF">2024-01-05T10:52:35Z</dcterms:created>
  <dcterms:modified xsi:type="dcterms:W3CDTF">2025-05-21T16:32:48Z</dcterms:modified>
</cp:coreProperties>
</file>